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DD5BD-AF04-450E-A028-45E770B364D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B7017-CF24-43E1-8112-4C243D1F5B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999A0-BA83-43AA-96FC-4ED63EDC440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A0975-C55D-4DD4-89A8-06696BF4AF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646E6-5E63-4729-B00E-01C33EF6A5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5596BD-531F-4A6A-941C-393CF4458F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7CDB6-2231-4592-B4E2-7B3D500454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826319-4E94-4E4C-8FAA-98F4C7F200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E2B4C-93ED-423D-A765-6A19759CE1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E8B01A-DE22-4FC3-85EF-893003B82B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183DC9-8CD4-4E37-B8D2-92ABA29CDC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35FD9-CF4D-4495-AF0E-2415BCFF44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D3E9D25-C79A-419A-BE75-F9DE3CE2BB0B}" type="slidenum"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Oval 2"/>
          <p:cNvSpPr/>
          <p:nvPr/>
        </p:nvSpPr>
        <p:spPr>
          <a:xfrm>
            <a:off x="2336760" y="4251240"/>
            <a:ext cx="1330200" cy="107784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Oval 3"/>
          <p:cNvSpPr/>
          <p:nvPr/>
        </p:nvSpPr>
        <p:spPr>
          <a:xfrm>
            <a:off x="3166920" y="4251240"/>
            <a:ext cx="1330560" cy="107784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2853000" y="4037040"/>
            <a:ext cx="302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S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 Box 8"/>
          <p:cNvSpPr/>
          <p:nvPr/>
        </p:nvSpPr>
        <p:spPr>
          <a:xfrm>
            <a:off x="3238200" y="468324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32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 Box 11"/>
          <p:cNvSpPr/>
          <p:nvPr/>
        </p:nvSpPr>
        <p:spPr>
          <a:xfrm>
            <a:off x="2579400" y="468468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7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 Box 12"/>
          <p:cNvSpPr/>
          <p:nvPr/>
        </p:nvSpPr>
        <p:spPr>
          <a:xfrm>
            <a:off x="3846960" y="468324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1327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 Box 144"/>
          <p:cNvSpPr/>
          <p:nvPr/>
        </p:nvSpPr>
        <p:spPr>
          <a:xfrm>
            <a:off x="1662120" y="3909960"/>
            <a:ext cx="2350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5"/>
          <p:cNvSpPr/>
          <p:nvPr/>
        </p:nvSpPr>
        <p:spPr>
          <a:xfrm>
            <a:off x="3683160" y="4035600"/>
            <a:ext cx="302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L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9" name=""/>
          <p:cNvGraphicFramePr/>
          <p:nvPr/>
        </p:nvGraphicFramePr>
        <p:xfrm>
          <a:off x="1454040" y="2205000"/>
          <a:ext cx="3875040" cy="925560"/>
        </p:xfrm>
        <a:graphic>
          <a:graphicData uri="http://schemas.openxmlformats.org/drawingml/2006/table">
            <a:tbl>
              <a:tblPr/>
              <a:tblGrid>
                <a:gridCol w="833400"/>
                <a:gridCol w="1014480"/>
                <a:gridCol w="1013040"/>
                <a:gridCol w="1014120"/>
              </a:tblGrid>
              <a:tr h="335160">
                <a:tc rowSpan="2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Conditio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gridSpan="3"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Number of differentially expressed genes (DEGs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2134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U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Dow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To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348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S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6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4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601"/>
                        </a:spcBef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10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13480"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L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9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65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685800"/>
                          <a:tab algn="l" pos="1371600"/>
                          <a:tab algn="l" pos="2057400"/>
                          <a:tab algn="l" pos="2743200"/>
                          <a:tab algn="l" pos="3429000"/>
                          <a:tab algn="l" pos="4114800"/>
                          <a:tab algn="l" pos="4800600"/>
                          <a:tab algn="l" pos="5486400"/>
                          <a:tab algn="l" pos="6172200"/>
                          <a:tab algn="l" pos="6858000"/>
                          <a:tab algn="l" pos="7543800"/>
                          <a:tab algn="l" pos="8229600"/>
                          <a:tab algn="l" pos="8915400"/>
                          <a:tab algn="l" pos="9601200"/>
                          <a:tab algn="l" pos="10287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ourier New"/>
                          <a:ea typeface="等线"/>
                        </a:rPr>
                        <a:t>16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1440" marR="914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0" name="Text Box 144"/>
          <p:cNvSpPr/>
          <p:nvPr/>
        </p:nvSpPr>
        <p:spPr>
          <a:xfrm>
            <a:off x="1668600" y="1838160"/>
            <a:ext cx="2332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矩形 5"/>
          <p:cNvSpPr/>
          <p:nvPr/>
        </p:nvSpPr>
        <p:spPr>
          <a:xfrm>
            <a:off x="706320" y="6124680"/>
            <a:ext cx="5573880" cy="119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4: Figure S2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. Summary of differentially expressed genes (DEGs) identified between th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-overexpression line OX707-#21 and wild-type. (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)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Number of DEGs between OX707-#21 and wild-type under short day (SD) and long day (LD) conditions, respectively. Up, up-regulated in OX707-#21; Down, down-regulated in OX707-#21. </a:t>
            </a: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(B)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Venn diagrams of DEGs between OX707-#21 and wild-type under SD and LD.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6-01T05:41:34Z</dcterms:created>
  <dc:creator>csb</dc:creator>
  <dc:description/>
  <dc:language>en-US</dc:language>
  <cp:lastModifiedBy>csb</cp:lastModifiedBy>
  <cp:lastPrinted>2020-09-17T07:01:04Z</cp:lastPrinted>
  <dcterms:modified xsi:type="dcterms:W3CDTF">2020-12-01T13:36:10Z</dcterms:modified>
  <cp:revision>172</cp:revision>
  <dc:subject/>
  <dc:title>PowerPoint 演示文稿</dc:title>
</cp:coreProperties>
</file>